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dt" idx="7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ftr" idx="8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 type="sldNum" idx="9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AC477F-F0D3-420F-A618-837A06B2774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1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EC9282-B825-43D5-8C88-905FEC170A6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0B1913-F343-4FBB-938E-281A7DE75CE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1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A97E9B-1EE9-45F2-A9C1-EB6494AAFA8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2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4C6B88-6175-4BC5-8347-DE9BCBF6F26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2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EB3982-5E93-4C09-9CFF-ED8EFD0D6AC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2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F23CDA-241B-4783-A89A-768B04A65E8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2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6940C6-0369-4C99-92DD-E9AF5B6CBA2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3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9A124F-B6FB-44B0-9B40-076E1B505D1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3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590648-BDD2-4F89-9B9F-0C60C66C0E7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42825-76B2-49A3-8C5A-2A4FC29BD1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834E3-69CF-40BF-9211-14CD857587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7C4D7-7F2E-4CD6-92A5-47A1B62EC7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730CB-0985-474B-9404-1A50FDC516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34A8701-651A-40A4-8405-02C8DE38A4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13E10EB-A037-469D-A030-439C66961A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04B9B7-09A6-47CD-9AB4-EE26260BB2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80A298-45CA-4759-BDA0-DCB23EADB0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A82BC1-FF8F-4D5F-9555-1D0A968E87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01BC214-39BE-4C84-A466-7FA2C348A7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084904-6A2A-4B6A-A6C3-C1DB27F919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CBB5E-D1F6-454A-924A-6C25309530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993B59-7E5B-4C0F-8AE9-5BCDFE7BF3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15A5562-DA55-460E-803B-F4C37CB270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2E05184-2861-46A3-89A5-54333DBF19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7CCD21C-5DD3-4824-83AC-1C59EFBB84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9A82F17-9EF1-4F1A-A346-692143EE4D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CFF7C-6713-4F7B-AE99-39893B1283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241E2-7EB4-4B3D-8D65-B7E284E447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7F410-64C5-4911-AB05-7936632016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A5893-570D-443C-AAE2-93C9292870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4D486-FD9D-40E7-9DCC-2A9ADF9D65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B9B4A-FDB9-4537-BAAA-E06973D68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3240F4-37EB-4312-8ECE-9F966AFE37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E5F86E-69FE-4154-8348-CD26C364866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4F649A-3CFD-494A-B91E-40947136047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152280" y="152280"/>
            <a:ext cx="7391520" cy="533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1: Genome size vs original host / #ORF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0" name="Picture 3" descr="Suppl_figure_1.tiff"/>
          <p:cNvPicPr/>
          <p:nvPr/>
        </p:nvPicPr>
        <p:blipFill>
          <a:blip r:embed="rId1"/>
          <a:stretch/>
        </p:blipFill>
        <p:spPr>
          <a:xfrm>
            <a:off x="0" y="762120"/>
            <a:ext cx="9144000" cy="6095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76320" y="151920"/>
            <a:ext cx="777240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2: Genome synteny among T4 phages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traight Connector 14"/>
          <p:cNvSpPr/>
          <p:nvPr/>
        </p:nvSpPr>
        <p:spPr>
          <a:xfrm>
            <a:off x="-533520" y="457200"/>
            <a:ext cx="0" cy="220968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traight Connector 16"/>
          <p:cNvSpPr/>
          <p:nvPr/>
        </p:nvSpPr>
        <p:spPr>
          <a:xfrm flipH="1">
            <a:off x="-533520" y="533520"/>
            <a:ext cx="533520" cy="213336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Picture 14" descr="Supp_fig_2.tiff"/>
          <p:cNvPicPr/>
          <p:nvPr/>
        </p:nvPicPr>
        <p:blipFill>
          <a:blip r:embed="rId1"/>
          <a:srcRect l="0" t="4442" r="0" b="3335"/>
          <a:stretch/>
        </p:blipFill>
        <p:spPr>
          <a:xfrm>
            <a:off x="135000" y="533520"/>
            <a:ext cx="8874000" cy="6324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304920" y="685800"/>
            <a:ext cx="3581280" cy="533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3: gp51 alignmen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" name="Picture 3" descr="Supplementary_figure_3.tif"/>
          <p:cNvPicPr/>
          <p:nvPr/>
        </p:nvPicPr>
        <p:blipFill>
          <a:blip r:embed="rId1"/>
          <a:srcRect l="0" t="22220" r="0" b="32226"/>
          <a:stretch/>
        </p:blipFill>
        <p:spPr>
          <a:xfrm>
            <a:off x="152280" y="1828800"/>
            <a:ext cx="8872560" cy="3124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3" descr="Suppl_fig_4.tiff"/>
          <p:cNvPicPr/>
          <p:nvPr/>
        </p:nvPicPr>
        <p:blipFill>
          <a:blip r:embed="rId1"/>
          <a:stretch/>
        </p:blipFill>
        <p:spPr>
          <a:xfrm>
            <a:off x="152280" y="0"/>
            <a:ext cx="8875800" cy="6858000"/>
          </a:xfrm>
          <a:prstGeom prst="rect">
            <a:avLst/>
          </a:prstGeom>
          <a:ln w="0">
            <a:noFill/>
          </a:ln>
        </p:spPr>
      </p:pic>
      <p:sp>
        <p:nvSpPr>
          <p:cNvPr id="98" name="TextBox 2"/>
          <p:cNvSpPr/>
          <p:nvPr/>
        </p:nvSpPr>
        <p:spPr>
          <a:xfrm>
            <a:off x="416520" y="152280"/>
            <a:ext cx="2865960" cy="429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uppl. Fig. 4: MazG tree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685440" y="380880"/>
            <a:ext cx="5181480" cy="533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5: Weblogos of promoters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0" name="Picture 3" descr="Suppl_fig_5.tiff"/>
          <p:cNvPicPr/>
          <p:nvPr/>
        </p:nvPicPr>
        <p:blipFill>
          <a:blip r:embed="rId1"/>
          <a:srcRect l="0" t="20000" r="0" b="24445"/>
          <a:stretch/>
        </p:blipFill>
        <p:spPr>
          <a:xfrm>
            <a:off x="135000" y="1371600"/>
            <a:ext cx="8874000" cy="380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3" descr="Supp_fig_6.tiff"/>
          <p:cNvPicPr/>
          <p:nvPr/>
        </p:nvPicPr>
        <p:blipFill>
          <a:blip r:embed="rId1"/>
          <a:srcRect l="0" t="4442" r="0" b="7776"/>
          <a:stretch/>
        </p:blipFill>
        <p:spPr>
          <a:xfrm>
            <a:off x="139680" y="380880"/>
            <a:ext cx="8852040" cy="6477120"/>
          </a:xfrm>
          <a:prstGeom prst="rect">
            <a:avLst/>
          </a:prstGeom>
          <a:ln w="0">
            <a:noFill/>
          </a:ln>
        </p:spPr>
      </p:pic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-360" y="0"/>
            <a:ext cx="3962520" cy="4572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6: Zwf alignmen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152280" y="152280"/>
            <a:ext cx="4724640" cy="6098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7: Endonuclease alignment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4" name="Picture 3" descr="Supp_figure_7.tiff"/>
          <p:cNvPicPr/>
          <p:nvPr/>
        </p:nvPicPr>
        <p:blipFill>
          <a:blip r:embed="rId1"/>
          <a:srcRect l="0" t="0" r="0" b="23333"/>
          <a:stretch/>
        </p:blipFill>
        <p:spPr>
          <a:xfrm>
            <a:off x="0" y="838080"/>
            <a:ext cx="8872560" cy="5257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266688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8: CP12 + talC close-up figur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6" name="Picture 3" descr="Supp_fig_8.tiff"/>
          <p:cNvPicPr/>
          <p:nvPr/>
        </p:nvPicPr>
        <p:blipFill>
          <a:blip r:embed="rId1"/>
          <a:stretch/>
        </p:blipFill>
        <p:spPr>
          <a:xfrm>
            <a:off x="2657520" y="0"/>
            <a:ext cx="648648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3581280" cy="1295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. Fig. 9: Mobile Hypothetical Genes Clust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8" name="Picture 3" descr="Supp_fig_9.tiff"/>
          <p:cNvPicPr/>
          <p:nvPr/>
        </p:nvPicPr>
        <p:blipFill>
          <a:blip r:embed="rId1"/>
          <a:stretch/>
        </p:blipFill>
        <p:spPr>
          <a:xfrm>
            <a:off x="3844800" y="0"/>
            <a:ext cx="52992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1T02:08:44Z</dcterms:created>
  <dc:creator>Joan Seah</dc:creator>
  <dc:description/>
  <dc:language>en-US</dc:language>
  <cp:lastModifiedBy>Joan Seah</cp:lastModifiedBy>
  <dcterms:modified xsi:type="dcterms:W3CDTF">2010-05-21T02:09:46Z</dcterms:modified>
  <cp:revision>1</cp:revision>
  <dc:subject/>
  <dc:title>Suppl. Fig. 1: Genome size vs original host / #ORFs</dc:title>
</cp:coreProperties>
</file>